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5C94F1-FADF-455A-A314-AAFEA1ACAAF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A12956-3318-4672-B8CA-EB2AC03A0B1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B35E97-BB02-43C0-839A-C5A6D29E873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815CE8-40FC-46EF-A479-4671C7F9F94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81E517-DE72-472B-8C1C-01F4FF37F0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4B71AA-1577-49DB-A0DF-C7CD544A53C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A57585-0B8E-4AC0-84B1-9CA0A6A7C4C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5C70EC-57B7-4EF1-BF4C-EB36479B57B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68558D-1C8E-4A3B-B4E0-30A2C1EC9B9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F3A4C2-A633-4435-BE0B-69318ED09C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D69559-98B8-44E3-BD88-25B66AABD3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6F0414-4AD0-42F2-83F7-89AB08620B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2077157-1A07-464D-BA6E-72BD289F377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"/>
          <p:cNvPicPr/>
          <p:nvPr/>
        </p:nvPicPr>
        <p:blipFill>
          <a:blip r:embed="rId1"/>
          <a:srcRect l="1049" t="21814" r="1568" b="22783"/>
          <a:stretch/>
        </p:blipFill>
        <p:spPr>
          <a:xfrm>
            <a:off x="152280" y="2057400"/>
            <a:ext cx="4343400" cy="26622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2" name="Picture 7" descr=""/>
          <p:cNvPicPr/>
          <p:nvPr/>
        </p:nvPicPr>
        <p:blipFill>
          <a:blip r:embed="rId2"/>
          <a:srcRect l="787" t="20840" r="1830" b="22783"/>
          <a:stretch/>
        </p:blipFill>
        <p:spPr>
          <a:xfrm>
            <a:off x="4648320" y="2057400"/>
            <a:ext cx="4343400" cy="26668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3" name="Text Box 1491"/>
          <p:cNvSpPr/>
          <p:nvPr/>
        </p:nvSpPr>
        <p:spPr>
          <a:xfrm>
            <a:off x="270000" y="1628640"/>
            <a:ext cx="1244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“Out of steep”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1492"/>
          <p:cNvSpPr/>
          <p:nvPr/>
        </p:nvSpPr>
        <p:spPr>
          <a:xfrm>
            <a:off x="4736160" y="1628640"/>
            <a:ext cx="1584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B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“3d of germination”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1177"/>
          <p:cNvSpPr/>
          <p:nvPr/>
        </p:nvSpPr>
        <p:spPr>
          <a:xfrm>
            <a:off x="306360" y="196920"/>
            <a:ext cx="85327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2. Venn diagrams of the differentially expressed genes between the most recent and older genotypes at both time points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06T23:24:22Z</dcterms:created>
  <dc:creator>CFANS</dc:creator>
  <dc:description/>
  <dc:language>en-US</dc:language>
  <cp:lastModifiedBy>CfansGopher</cp:lastModifiedBy>
  <dcterms:modified xsi:type="dcterms:W3CDTF">2010-05-13T15:16:59Z</dcterms:modified>
  <cp:revision>9</cp:revision>
  <dc:subject/>
  <dc:title>Slide 1</dc:title>
</cp:coreProperties>
</file>